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1466"/>
  </p:normalViewPr>
  <p:slideViewPr>
    <p:cSldViewPr snapToGrid="0" snapToObjects="1">
      <p:cViewPr varScale="1">
        <p:scale>
          <a:sx n="66" d="100"/>
          <a:sy n="66" d="100"/>
        </p:scale>
        <p:origin x="8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C4B83-FDF8-B244-9CB9-2B8E84C0E8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482963-52C0-FE48-8A6C-4BC6EC748D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AF6F8-85F2-4C4E-80C0-737BD84A0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93E02-073D-A641-95E9-A7EE458EB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9EBD89-01B4-A542-AAFC-F0D3581F1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95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6A224C-7A0A-BA4E-8687-A0C59645A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F6BEA7-772F-254A-B76A-01A9D5CBEC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0DF32-5F78-734E-B391-998AF69AB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DB5FF-38A3-6F4F-BDBA-F7ED60EBA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8571C0-90FC-9540-982C-C47DB8880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97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58454D-6448-D842-A2F5-4E0FF5DE44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926FD7-40A1-3C4F-A545-B846AF93F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637860-B5BA-0C48-800E-BB79E18B2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28804C-56CE-9047-B009-DE00577CA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1107E1-6F98-B34C-AD2C-39194788F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064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A45791-B64B-3745-A263-6F60EA7DF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4455BE-60E0-9948-AA9B-1CBAF803EF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690FA-77AE-7541-BA63-1534BD5C6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9C9DE7-A5E6-5742-8BD9-DC47E15CE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EC649-E78E-5E47-A2A8-A5BDACEFC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28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858CA1-A1DF-644D-86F8-041F1EAF2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D33383-B2AB-AF43-803C-C8537319A0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27C8D-54AE-8649-A21F-87A3C044C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E2A0B2-49DD-674E-94EC-D59322247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60BAE-4F14-0E48-88B5-0C2CAA82A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001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28DE2-D48C-C244-98FB-AE4944BE8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CD90B4-C211-F347-9553-420DC254C8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3422F2-1B6E-5A4B-AB7A-FC33FEE6F5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8FD495-624C-FC4E-9C80-7036F336F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3AE94B-7F3D-D444-87A4-9EB88BCED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2014B0-45F6-7E43-BDEE-3166D0011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898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9EF25-F85C-FC4E-9655-E8F26EA88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309BF3-15D2-0944-8332-2E331E2AC2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CD5D59-B20C-334B-85AE-87FD350147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613F3D-3B6B-1D43-92F2-8FCA11E019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B8A60C-5D6F-464B-8915-21A802AD57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8E43FF-D3A5-8244-9714-1188B21C0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37690A-EAEA-0D4D-8C22-096D40713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537ED9-64E9-424F-AB35-90E7C355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838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31D86-86D3-3247-BD26-F6C59C8C20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7D4190-365F-2747-812B-50EAED2AA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1A90B9-2876-7547-B098-976EEAAFA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EC91D7-DC66-1241-828C-8507CA8E0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529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77A012-C4B3-EC48-8EAF-0E9743169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9C525A-B830-1A4A-87C1-CAFF132B9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F74E36-D18A-8C49-A7C6-3761FD886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188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F6870-709B-ED45-A731-74FBB14FA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DBA21A-6D1E-9D45-B344-351E4CD2B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FE11F8-21DF-3741-9570-446C15B289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F3D56D-FA8B-F848-88E5-87E2E979F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879A07-3B09-864A-A538-344EF2E89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5C4FF6-3736-6947-A80E-5759121E7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771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F2EAB-2D03-D64D-A7E2-27CEEA365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66F888-422D-A54B-9B4C-7361CDA1C9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E55858-1676-574E-9465-3F75CEDDC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1AF57B-5BA3-4548-BD21-7BE9D7F84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ED6CEC-723A-5143-A600-D926F93A8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932411-2BDA-CD4F-90FC-D82DDF7EE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555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FAA2EC-85E7-3449-8650-EBAB498A7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98C689-B793-B449-AD5F-9A98BF928D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9F56B0-60A4-7545-B967-8FAC940949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340A3-AE86-3B42-8C79-BF9B8305A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944CF9-AEED-0E4C-883F-5FF8DB9B2F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730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D7535E35-5678-7347-A240-37D05C799AA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0755111"/>
              </p:ext>
            </p:extLst>
          </p:nvPr>
        </p:nvGraphicFramePr>
        <p:xfrm>
          <a:off x="222421" y="1172053"/>
          <a:ext cx="11727123" cy="3396042"/>
        </p:xfrm>
        <a:graphic>
          <a:graphicData uri="http://schemas.openxmlformats.org/drawingml/2006/table">
            <a:tbl>
              <a:tblPr firstRow="1" firstCol="1" bandRow="1"/>
              <a:tblGrid>
                <a:gridCol w="1874008">
                  <a:extLst>
                    <a:ext uri="{9D8B030D-6E8A-4147-A177-3AD203B41FA5}">
                      <a16:colId xmlns:a16="http://schemas.microsoft.com/office/drawing/2014/main" val="2214308963"/>
                    </a:ext>
                  </a:extLst>
                </a:gridCol>
                <a:gridCol w="9853115">
                  <a:extLst>
                    <a:ext uri="{9D8B030D-6E8A-4147-A177-3AD203B41FA5}">
                      <a16:colId xmlns:a16="http://schemas.microsoft.com/office/drawing/2014/main" val="147799064"/>
                    </a:ext>
                  </a:extLst>
                </a:gridCol>
              </a:tblGrid>
              <a:tr h="33669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 (</a:t>
                      </a:r>
                      <a:r>
                        <a:rPr lang="en-US" sz="1200" i="1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. coli </a:t>
                      </a:r>
                      <a:r>
                        <a:rPr lang="en-US" sz="12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NM20070465) 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C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415788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46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7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</a:t>
                      </a:r>
                      <a:r>
                        <a:rPr lang="en-US" sz="1400" b="1" dirty="0">
                          <a:solidFill>
                            <a:srgbClr val="C00000"/>
                          </a:solidFill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TAATAAATATTA</a:t>
                      </a:r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2413186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91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8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</a:t>
                      </a:r>
                      <a:r>
                        <a:rPr lang="en-US" sz="1400" b="1" dirty="0">
                          <a:solidFill>
                            <a:srgbClr val="C00000"/>
                          </a:solidFill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8919305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92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50769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93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6901128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96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762485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00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3723377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02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377254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04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9186002"/>
                  </a:ext>
                </a:extLst>
              </a:tr>
              <a:tr h="3366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11 </a:t>
                      </a:r>
                      <a:r>
                        <a:rPr lang="en-US" sz="1400" dirty="0" err="1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meRAIVS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ype 0)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TAAGTAAATATAAAAATTATTAACCAAATTTGAGCTATAATATGTCTTAAAAATTGTGTAATAAATATTA</a:t>
                      </a: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400" dirty="0">
                          <a:effectLst/>
                          <a:latin typeface="+mj-lt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ATATATTTAAATTAAAAATTTTAAGGCAAAAATC</a:t>
                      </a:r>
                      <a:endParaRPr lang="en-US" sz="1400" dirty="0">
                        <a:effectLst/>
                        <a:latin typeface="+mj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079" marR="59079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4406081"/>
                  </a:ext>
                </a:extLst>
              </a:tr>
            </a:tbl>
          </a:graphicData>
        </a:graphic>
      </p:graphicFrame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BA6AD8B-BD9D-B443-B9F5-68E9171FD41C}"/>
              </a:ext>
            </a:extLst>
          </p:cNvPr>
          <p:cNvCxnSpPr>
            <a:cxnSpLocks/>
          </p:cNvCxnSpPr>
          <p:nvPr/>
        </p:nvCxnSpPr>
        <p:spPr>
          <a:xfrm>
            <a:off x="7309258" y="1133237"/>
            <a:ext cx="0" cy="267669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FFB9AA78-AF9F-9048-9E8F-A071F8DF430D}"/>
              </a:ext>
            </a:extLst>
          </p:cNvPr>
          <p:cNvGrpSpPr/>
          <p:nvPr/>
        </p:nvGrpSpPr>
        <p:grpSpPr>
          <a:xfrm>
            <a:off x="7080605" y="825573"/>
            <a:ext cx="1861677" cy="3826965"/>
            <a:chOff x="6959419" y="2202302"/>
            <a:chExt cx="1861677" cy="3826965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EEB0E1A4-235C-5540-9F98-E025D8258D68}"/>
                </a:ext>
              </a:extLst>
            </p:cNvPr>
            <p:cNvSpPr/>
            <p:nvPr/>
          </p:nvSpPr>
          <p:spPr>
            <a:xfrm>
              <a:off x="7186784" y="2662287"/>
              <a:ext cx="1417320" cy="3366980"/>
            </a:xfrm>
            <a:prstGeom prst="rect">
              <a:avLst/>
            </a:prstGeom>
            <a:noFill/>
            <a:ln w="3682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DECC186-9382-BA4E-9118-116833FE6FFD}"/>
                </a:ext>
              </a:extLst>
            </p:cNvPr>
            <p:cNvSpPr txBox="1"/>
            <p:nvPr/>
          </p:nvSpPr>
          <p:spPr>
            <a:xfrm>
              <a:off x="6959419" y="2211533"/>
              <a:ext cx="4555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5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DDD774A-1A1A-0B46-BF2D-625C60CBB6EE}"/>
                </a:ext>
              </a:extLst>
            </p:cNvPr>
            <p:cNvSpPr txBox="1"/>
            <p:nvPr/>
          </p:nvSpPr>
          <p:spPr>
            <a:xfrm>
              <a:off x="8365522" y="2202302"/>
              <a:ext cx="4555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4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CBDACA87-DAAD-9245-AEA0-EB1FDE93650A}"/>
                </a:ext>
              </a:extLst>
            </p:cNvPr>
            <p:cNvCxnSpPr>
              <a:cxnSpLocks/>
            </p:cNvCxnSpPr>
            <p:nvPr/>
          </p:nvCxnSpPr>
          <p:spPr>
            <a:xfrm>
              <a:off x="8607799" y="2519199"/>
              <a:ext cx="0" cy="267669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4CEE64EA-B063-9645-9372-CE48661F86E8}"/>
              </a:ext>
            </a:extLst>
          </p:cNvPr>
          <p:cNvSpPr txBox="1"/>
          <p:nvPr/>
        </p:nvSpPr>
        <p:spPr>
          <a:xfrm>
            <a:off x="11615129" y="889739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008ED86-0744-F844-A840-F79ACD691E03}"/>
              </a:ext>
            </a:extLst>
          </p:cNvPr>
          <p:cNvSpPr txBox="1"/>
          <p:nvPr/>
        </p:nvSpPr>
        <p:spPr>
          <a:xfrm>
            <a:off x="2021378" y="871282"/>
            <a:ext cx="463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B95D270-44E8-1645-885C-561E41D7E5CB}"/>
              </a:ext>
            </a:extLst>
          </p:cNvPr>
          <p:cNvSpPr txBox="1"/>
          <p:nvPr/>
        </p:nvSpPr>
        <p:spPr>
          <a:xfrm>
            <a:off x="414906" y="176028"/>
            <a:ext cx="111108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 Fig: 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intergenic region of </a:t>
            </a:r>
            <a:r>
              <a:rPr lang="en-US" b="1" i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pylobacter coli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NM20070465 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ference strain with 9 ERY</a:t>
            </a:r>
            <a:r>
              <a:rPr lang="en-US" b="1" baseline="30000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i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coli 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olates. </a:t>
            </a:r>
          </a:p>
        </p:txBody>
      </p:sp>
    </p:spTree>
    <p:extLst>
      <p:ext uri="{BB962C8B-B14F-4D97-AF65-F5344CB8AC3E}">
        <p14:creationId xmlns:p14="http://schemas.microsoft.com/office/powerpoint/2010/main" val="2138466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102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imaa Mahmoud</dc:creator>
  <cp:lastModifiedBy>Sathish Kumar</cp:lastModifiedBy>
  <cp:revision>22</cp:revision>
  <dcterms:created xsi:type="dcterms:W3CDTF">2020-07-14T15:42:07Z</dcterms:created>
  <dcterms:modified xsi:type="dcterms:W3CDTF">2021-06-17T11:31:06Z</dcterms:modified>
</cp:coreProperties>
</file>